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629"/>
  </p:normalViewPr>
  <p:slideViewPr>
    <p:cSldViewPr snapToGrid="0">
      <p:cViewPr varScale="1">
        <p:scale>
          <a:sx n="103" d="100"/>
          <a:sy n="103" d="100"/>
        </p:scale>
        <p:origin x="5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41061D-8190-FF03-920E-7724D144B9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B7D4CBB-4ACC-3240-70B9-175E2152EC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6A52CE-1840-376F-43FC-244AF330A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ECFE60-E4A7-8F3B-1573-F5AC8A54F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F2D210-25C0-6649-5E44-9677357A7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3094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9D3822-7481-2060-ED22-9C764A83DE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B66796-6B6D-02BD-F8EB-BB9E1A3E69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3676B2-8DEA-D268-2F6D-AFD1EFD09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2DE27A-6A95-9EDD-FDC4-82FA21F7B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146FC4-A9DB-03CB-2022-2561BAEE6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408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4A6A334-9395-F884-5F8B-2113CBE54A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6CAEA4B-7DE7-A1B1-0257-FA4064F732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5477AB-ADD0-37CA-9AC9-EDD588FB8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484B4F-E628-9F16-C999-A5A149B1D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4CDE3F-2349-2B5F-D8F8-3B1D72180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732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46B9E2-F9B9-2002-FB13-D271C4880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0C2ED3-7876-212D-D9B6-FFC7A2D052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4F41DB-12E9-8831-7C09-EC5329D0C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3B0DB2-9C69-C280-E826-8C444F4AA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DCBBBF-9978-8587-4B73-1D32EE620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907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263C5E-4B3E-8045-3A99-EFB654594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998AB6-95F5-8E62-C372-FF239CE47D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900A4E-DDF3-658A-4CAD-B10095080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CB8715-4A80-FAC8-4E4A-1E0C2E68B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5A2352-5F8E-CE6D-9D4B-6889D0E2F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247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D39AE7-0E6C-8DCB-E96C-1F8F7407C8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F26614-B85E-B558-569C-C999C4A5E2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2F1587-2B5E-8BBD-1A01-B097468964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484E408-3C06-B7BD-BFBD-947DCF9B4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5E7AD7-E133-7B55-E390-90EECAD77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947830-5832-5B1E-5A8D-D7A2CB616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57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477064-C82C-7BA4-F2FB-52F54E124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A4F9E6A-E17E-A067-0E49-057C92670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DBED81F-2512-BCFF-9F06-874B7F6CCA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919E7C4-5A09-67CC-BA97-4951C11D94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6A3CCA6-7E4C-0984-EE55-353A6ECC3B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A05FA8E-7D89-00CD-325A-D73EB1130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2C31FF1-0536-051F-58DC-7B6980045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865B184-6EE9-BC59-323A-FCE9ECCDD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466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07A97D-2D78-AADA-3F3B-CCA606944F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DD0B3EF-213E-6BE5-DF29-2B0C2F3E3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08C81CF-2F34-1DC7-3CD3-9C5C529FD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93CC808-4C42-7430-4408-DDD07D92F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861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A1765AF-72DC-10D3-4A38-65D1C4CFB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0A36280-DE89-AFB8-7E91-4C34E6CF5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DD3BCA2-6550-D1E0-8B21-04E67957E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078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0444A1-3103-1384-CC79-309A0B121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35D51B5-9670-5D59-C824-6A8D33AA14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FA6D8F7-A3E4-C48D-5A89-EEA5187519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B53592-AB52-EEE0-D891-74F3B75B7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D98324-E15A-C9FF-2839-11BCDF374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7B0B4E-76DF-93E5-76F0-DEF63F27F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083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B494CD-D35A-7634-9C05-B050B4573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1FB3646-BD14-61A7-EE2B-4010BD5539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715CF22-CC31-E235-A3BF-CDCA53D8F4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595DE6E-13E4-5027-116F-C9B5E25AC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4C905D-9D5D-F88E-B805-09C443121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36E0CD-E8AB-0CE7-DE72-F0B88A8C6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205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73E23C1-5473-2063-795D-4D4DB4A79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CD61DE-2D27-36C8-D7B4-A87CF9AA74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81FFC8-0DDF-B177-DBD4-45EF0037FB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6F1B7-099F-614D-9F14-FDFF7A68BE33}" type="datetimeFigureOut">
              <a:rPr kumimoji="1" lang="ja-JP" altLang="en-US" smtClean="0"/>
              <a:t>2023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B3BB150-6989-DD37-6EEA-DA0D05E4D9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DF2486-E5D4-15F2-FDD3-8D29591FCB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03272-B545-F14F-A69F-1EB9B3242E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846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06B9FE9-6030-D770-55B6-AB07DE588F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63516" y="1091129"/>
            <a:ext cx="3352315" cy="436998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C068708-23AC-94A2-4C32-CD72A1CD20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341"/>
          <a:stretch/>
        </p:blipFill>
        <p:spPr>
          <a:xfrm>
            <a:off x="589794" y="1109017"/>
            <a:ext cx="3574894" cy="3656641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FD9F911-5229-4914-7A7D-6AB4B20B1D69}"/>
              </a:ext>
            </a:extLst>
          </p:cNvPr>
          <p:cNvSpPr txBox="1"/>
          <p:nvPr/>
        </p:nvSpPr>
        <p:spPr>
          <a:xfrm>
            <a:off x="1406038" y="47085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40</a:t>
            </a:r>
            <a:endParaRPr kumimoji="1" lang="ja-JP" altLang="en-US" sz="16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1C6B556-BD02-DED8-3C09-FE7E76FB7AD5}"/>
              </a:ext>
            </a:extLst>
          </p:cNvPr>
          <p:cNvSpPr txBox="1"/>
          <p:nvPr/>
        </p:nvSpPr>
        <p:spPr>
          <a:xfrm>
            <a:off x="1949291" y="47085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5</a:t>
            </a:r>
            <a:r>
              <a:rPr kumimoji="1"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B1907C1-8DF7-BD8E-1CCF-2B5CF6B0DF8A}"/>
              </a:ext>
            </a:extLst>
          </p:cNvPr>
          <p:cNvSpPr txBox="1"/>
          <p:nvPr/>
        </p:nvSpPr>
        <p:spPr>
          <a:xfrm>
            <a:off x="2492544" y="47085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60</a:t>
            </a:r>
            <a:endParaRPr kumimoji="1" lang="ja-JP" altLang="en-US" sz="16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0CCCD5C-51D9-9FCC-B945-8B627B7BF11B}"/>
              </a:ext>
            </a:extLst>
          </p:cNvPr>
          <p:cNvSpPr txBox="1"/>
          <p:nvPr/>
        </p:nvSpPr>
        <p:spPr>
          <a:xfrm>
            <a:off x="3035797" y="47085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70</a:t>
            </a:r>
            <a:endParaRPr kumimoji="1" lang="ja-JP" altLang="en-US" sz="16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98B1191-A41A-90B2-8F59-C1909E0F0834}"/>
              </a:ext>
            </a:extLst>
          </p:cNvPr>
          <p:cNvSpPr txBox="1"/>
          <p:nvPr/>
        </p:nvSpPr>
        <p:spPr>
          <a:xfrm>
            <a:off x="3579050" y="47085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8</a:t>
            </a:r>
            <a:r>
              <a:rPr kumimoji="1"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49DDCAA-6CB9-A00D-E5C0-40F5331DDD84}"/>
              </a:ext>
            </a:extLst>
          </p:cNvPr>
          <p:cNvSpPr txBox="1"/>
          <p:nvPr/>
        </p:nvSpPr>
        <p:spPr>
          <a:xfrm>
            <a:off x="1895714" y="5047062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Age (years)</a:t>
            </a:r>
            <a:endParaRPr kumimoji="1" lang="ja-JP" altLang="en-US" sz="14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EE21242-172D-05FF-0868-13EC2AFCC6C0}"/>
              </a:ext>
            </a:extLst>
          </p:cNvPr>
          <p:cNvSpPr txBox="1"/>
          <p:nvPr/>
        </p:nvSpPr>
        <p:spPr>
          <a:xfrm>
            <a:off x="880514" y="470850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3</a:t>
            </a:r>
            <a:r>
              <a:rPr kumimoji="1" lang="en-US" altLang="ja-JP" sz="16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0</a:t>
            </a:r>
            <a:endParaRPr kumimoji="1" lang="ja-JP" altLang="en-US" sz="16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9CCFE22-E4C6-2F00-6DB1-DC3822A909B0}"/>
              </a:ext>
            </a:extLst>
          </p:cNvPr>
          <p:cNvSpPr txBox="1"/>
          <p:nvPr/>
        </p:nvSpPr>
        <p:spPr>
          <a:xfrm rot="16200000">
            <a:off x="-237208" y="2836772"/>
            <a:ext cx="1261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Frequency (n)</a:t>
            </a:r>
            <a:endParaRPr kumimoji="1" lang="ja-JP" altLang="en-US" sz="1400" b="1"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8C1F0428-BA5D-B47A-DCBF-3E8B99C680D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705" r="21852"/>
          <a:stretch/>
        </p:blipFill>
        <p:spPr>
          <a:xfrm>
            <a:off x="5038103" y="1901502"/>
            <a:ext cx="2580567" cy="275590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5CA2AE7-7E90-C96F-2706-D10C249067C6}"/>
              </a:ext>
            </a:extLst>
          </p:cNvPr>
          <p:cNvSpPr txBox="1"/>
          <p:nvPr/>
        </p:nvSpPr>
        <p:spPr>
          <a:xfrm>
            <a:off x="4402273" y="2290753"/>
            <a:ext cx="18934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Distant or other </a:t>
            </a:r>
          </a:p>
          <a:p>
            <a:pPr algn="ctr"/>
            <a:r>
              <a:rPr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kumimoji="1"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etastasis</a:t>
            </a:r>
            <a:r>
              <a:rPr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(23.1%) 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60DEBFD-C092-7CDB-3935-7D2C82D3DE2B}"/>
              </a:ext>
            </a:extLst>
          </p:cNvPr>
          <p:cNvSpPr txBox="1"/>
          <p:nvPr/>
        </p:nvSpPr>
        <p:spPr>
          <a:xfrm>
            <a:off x="6783933" y="3231149"/>
            <a:ext cx="12121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Peritoneum</a:t>
            </a:r>
            <a:endParaRPr lang="en-US" altLang="ja-JP" sz="1600" b="1" dirty="0">
              <a:ln w="6350">
                <a:noFill/>
              </a:ln>
              <a:effectLst>
                <a:glow rad="127000">
                  <a:schemeClr val="bg1"/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61.2</a:t>
            </a:r>
            <a:r>
              <a:rPr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%)</a:t>
            </a:r>
            <a:endParaRPr kumimoji="1" lang="ja-JP" altLang="en-US" sz="1600" b="1">
              <a:ln w="6350">
                <a:noFill/>
              </a:ln>
              <a:effectLst>
                <a:glow rad="127000">
                  <a:schemeClr val="bg1"/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B7638A1-953A-99DD-1D95-6DB150068B1A}"/>
              </a:ext>
            </a:extLst>
          </p:cNvPr>
          <p:cNvSpPr txBox="1"/>
          <p:nvPr/>
        </p:nvSpPr>
        <p:spPr>
          <a:xfrm>
            <a:off x="4207232" y="3299203"/>
            <a:ext cx="18035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Lymph node alone</a:t>
            </a:r>
          </a:p>
          <a:p>
            <a:pPr algn="ctr"/>
            <a:r>
              <a:rPr lang="en-US" altLang="ja-JP" sz="16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15.7%)</a:t>
            </a:r>
            <a:endParaRPr kumimoji="1" lang="ja-JP" altLang="en-US" sz="1600" b="1">
              <a:ln w="6350">
                <a:noFill/>
              </a:ln>
              <a:effectLst>
                <a:glow rad="127000">
                  <a:schemeClr val="bg1"/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1943871-2173-AA02-BA63-4850B6AC9C75}"/>
              </a:ext>
            </a:extLst>
          </p:cNvPr>
          <p:cNvSpPr txBox="1"/>
          <p:nvPr/>
        </p:nvSpPr>
        <p:spPr>
          <a:xfrm>
            <a:off x="84485" y="708907"/>
            <a:ext cx="3706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ja-JP" sz="2000" b="1" dirty="0">
              <a:ln w="6350">
                <a:noFill/>
              </a:ln>
              <a:effectLst>
                <a:glow rad="127000">
                  <a:schemeClr val="bg1"/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271379A-784B-CFD3-BF09-2225C128025E}"/>
              </a:ext>
            </a:extLst>
          </p:cNvPr>
          <p:cNvSpPr txBox="1"/>
          <p:nvPr/>
        </p:nvSpPr>
        <p:spPr>
          <a:xfrm>
            <a:off x="4224179" y="708907"/>
            <a:ext cx="3561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ja-JP" sz="2000" b="1" dirty="0">
              <a:ln w="6350">
                <a:noFill/>
              </a:ln>
              <a:effectLst>
                <a:glow rad="127000">
                  <a:schemeClr val="bg1"/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238195E-1260-29F5-FA75-6AB7858A3173}"/>
              </a:ext>
            </a:extLst>
          </p:cNvPr>
          <p:cNvSpPr txBox="1"/>
          <p:nvPr/>
        </p:nvSpPr>
        <p:spPr>
          <a:xfrm>
            <a:off x="8278208" y="708907"/>
            <a:ext cx="3706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b="1" dirty="0">
                <a:ln w="6350">
                  <a:noFill/>
                </a:ln>
                <a:effectLst>
                  <a:glow rad="127000">
                    <a:schemeClr val="bg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ja-JP" sz="2000" b="1" dirty="0">
              <a:ln w="6350">
                <a:noFill/>
              </a:ln>
              <a:effectLst>
                <a:glow rad="127000">
                  <a:schemeClr val="bg1"/>
                </a:glo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0F8A549-5881-A8F1-D030-8FB32D07477F}"/>
              </a:ext>
            </a:extLst>
          </p:cNvPr>
          <p:cNvSpPr txBox="1"/>
          <p:nvPr/>
        </p:nvSpPr>
        <p:spPr>
          <a:xfrm>
            <a:off x="239813" y="5671751"/>
            <a:ext cx="116844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S1.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</a:rPr>
              <a:t> (A)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 distribution of age</a:t>
            </a: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and</a:t>
            </a:r>
            <a:r>
              <a:rPr lang="en-US" altLang="ja-JP" dirty="0">
                <a:effectLst/>
              </a:rPr>
              <a:t>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</a:rPr>
              <a:t>(B)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p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ie chart of the distribution of recurrent site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</a:rPr>
              <a:t>. (C) Plot of peritoneum-specific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recurrent-free interval of the two age group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094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47</TotalTime>
  <Words>71</Words>
  <Application>Microsoft Macintosh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吉原 雅人</dc:creator>
  <cp:lastModifiedBy>雅人 吉原</cp:lastModifiedBy>
  <cp:revision>6</cp:revision>
  <dcterms:created xsi:type="dcterms:W3CDTF">2022-12-13T20:44:00Z</dcterms:created>
  <dcterms:modified xsi:type="dcterms:W3CDTF">2023-09-24T11:14:03Z</dcterms:modified>
</cp:coreProperties>
</file>